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90" autoAdjust="0"/>
    <p:restoredTop sz="94660"/>
  </p:normalViewPr>
  <p:slideViewPr>
    <p:cSldViewPr snapToGrid="0">
      <p:cViewPr varScale="1">
        <p:scale>
          <a:sx n="157" d="100"/>
          <a:sy n="157" d="100"/>
        </p:scale>
        <p:origin x="156" y="7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5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6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C3 II</a:t>
            </a:r>
            <a:endParaRPr lang="zh-CN" altLang="en-US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4079092686037419"/>
          <c:y val="3.5933759755747398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:$A$7</c:f>
              <c:strCache>
                <c:ptCount val="6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  <c:pt idx="4">
                  <c:v>3-MA</c:v>
                </c:pt>
                <c:pt idx="5">
                  <c:v>RSV+CFZ+3-MA</c:v>
                </c:pt>
              </c:strCache>
            </c:strRef>
          </c:cat>
          <c:val>
            <c:numRef>
              <c:f>Sheet1!$E$2:$E$7</c:f>
              <c:numCache>
                <c:formatCode>General</c:formatCode>
                <c:ptCount val="6"/>
                <c:pt idx="0">
                  <c:v>1</c:v>
                </c:pt>
                <c:pt idx="1">
                  <c:v>1.3132998208530311</c:v>
                </c:pt>
                <c:pt idx="2">
                  <c:v>1.4366255286073488</c:v>
                </c:pt>
                <c:pt idx="3">
                  <c:v>1.6601698192847472</c:v>
                </c:pt>
                <c:pt idx="4">
                  <c:v>0.8781675283814222</c:v>
                </c:pt>
                <c:pt idx="5">
                  <c:v>1.202912194752686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56219584"/>
        <c:axId val="256220144"/>
      </c:barChart>
      <c:catAx>
        <c:axId val="2562195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6220144"/>
        <c:crosses val="autoZero"/>
        <c:auto val="1"/>
        <c:lblAlgn val="ctr"/>
        <c:lblOffset val="100"/>
        <c:noMultiLvlLbl val="0"/>
      </c:catAx>
      <c:valAx>
        <c:axId val="25622014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621958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62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8750883548871093"/>
          <c:y val="0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:$A$7</c:f>
              <c:strCache>
                <c:ptCount val="6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  <c:pt idx="4">
                  <c:v>3-MA</c:v>
                </c:pt>
                <c:pt idx="5">
                  <c:v>RSV+CFZ+3-MA</c:v>
                </c:pt>
              </c:strCache>
            </c:strRef>
          </c:cat>
          <c:val>
            <c:numRef>
              <c:f>Sheet1!$F$2:$F$7</c:f>
              <c:numCache>
                <c:formatCode>General</c:formatCode>
                <c:ptCount val="6"/>
                <c:pt idx="0">
                  <c:v>1</c:v>
                </c:pt>
                <c:pt idx="1">
                  <c:v>1.5444246165458975</c:v>
                </c:pt>
                <c:pt idx="2">
                  <c:v>2.1153225708086416</c:v>
                </c:pt>
                <c:pt idx="3">
                  <c:v>2.3491957391874045</c:v>
                </c:pt>
                <c:pt idx="4">
                  <c:v>0.65654702242223539</c:v>
                </c:pt>
                <c:pt idx="5">
                  <c:v>2.06585828290206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55419392"/>
        <c:axId val="255419952"/>
      </c:barChart>
      <c:catAx>
        <c:axId val="2554193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5419952"/>
        <c:crosses val="autoZero"/>
        <c:auto val="1"/>
        <c:lblAlgn val="ctr"/>
        <c:lblOffset val="100"/>
        <c:noMultiLvlLbl val="0"/>
      </c:catAx>
      <c:valAx>
        <c:axId val="25541995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541939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caspase</a:t>
            </a:r>
            <a:r>
              <a:rPr lang="en-US" altLang="zh-CN" baseline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3</a:t>
            </a:r>
            <a:endParaRPr lang="zh-CN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4228325976220553"/>
          <c:y val="0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:$A$7</c:f>
              <c:strCache>
                <c:ptCount val="6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  <c:pt idx="4">
                  <c:v>3-MA</c:v>
                </c:pt>
                <c:pt idx="5">
                  <c:v>RSV+CFZ+3-MA</c:v>
                </c:pt>
              </c:strCache>
            </c:strRef>
          </c:cat>
          <c:val>
            <c:numRef>
              <c:f>Sheet1!$G$2:$G$7</c:f>
              <c:numCache>
                <c:formatCode>General</c:formatCode>
                <c:ptCount val="6"/>
                <c:pt idx="0">
                  <c:v>1</c:v>
                </c:pt>
                <c:pt idx="1">
                  <c:v>0.90876545636480599</c:v>
                </c:pt>
                <c:pt idx="2">
                  <c:v>2.4858367395124188</c:v>
                </c:pt>
                <c:pt idx="3">
                  <c:v>2.097043812056357</c:v>
                </c:pt>
                <c:pt idx="4">
                  <c:v>1.4236061639359843</c:v>
                </c:pt>
                <c:pt idx="5">
                  <c:v>5.340553979613585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55422192"/>
        <c:axId val="255422752"/>
      </c:barChart>
      <c:catAx>
        <c:axId val="2554221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5422752"/>
        <c:crosses val="autoZero"/>
        <c:auto val="1"/>
        <c:lblAlgn val="ctr"/>
        <c:lblOffset val="100"/>
        <c:noMultiLvlLbl val="0"/>
      </c:catAx>
      <c:valAx>
        <c:axId val="25542275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542219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1400" b="0" i="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C3 II</a:t>
            </a:r>
            <a:endParaRPr lang="zh-CN" altLang="zh-CN" sz="1400" dirty="0"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1619032885313506"/>
          <c:y val="4.3214487566973984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4:$A$29</c:f>
              <c:strCache>
                <c:ptCount val="6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  <c:pt idx="4">
                  <c:v>3-MA</c:v>
                </c:pt>
                <c:pt idx="5">
                  <c:v>RSV+CFZ+3-MA</c:v>
                </c:pt>
              </c:strCache>
            </c:strRef>
          </c:cat>
          <c:val>
            <c:numRef>
              <c:f>Sheet1!$E$24:$E$29</c:f>
              <c:numCache>
                <c:formatCode>General</c:formatCode>
                <c:ptCount val="6"/>
                <c:pt idx="0">
                  <c:v>1</c:v>
                </c:pt>
                <c:pt idx="1">
                  <c:v>0.37070150287820341</c:v>
                </c:pt>
                <c:pt idx="2">
                  <c:v>0.22185049434180518</c:v>
                </c:pt>
                <c:pt idx="3">
                  <c:v>10.127947415945776</c:v>
                </c:pt>
                <c:pt idx="4">
                  <c:v>0.6659738718672723</c:v>
                </c:pt>
                <c:pt idx="5">
                  <c:v>7.23145215409852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55424992"/>
        <c:axId val="255425552"/>
      </c:barChart>
      <c:catAx>
        <c:axId val="2554249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5425552"/>
        <c:crosses val="autoZero"/>
        <c:auto val="1"/>
        <c:lblAlgn val="ctr"/>
        <c:lblOffset val="100"/>
        <c:noMultiLvlLbl val="0"/>
      </c:catAx>
      <c:valAx>
        <c:axId val="25542555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542499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1400" b="0" i="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-caspase</a:t>
            </a:r>
            <a:r>
              <a:rPr lang="en-US" altLang="zh-CN" sz="1400" b="0" i="0" baseline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3</a:t>
            </a:r>
            <a:endParaRPr lang="zh-CN" altLang="zh-CN" sz="140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3856384874507423"/>
          <c:y val="1.8164368945508325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4:$A$29</c:f>
              <c:strCache>
                <c:ptCount val="6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  <c:pt idx="4">
                  <c:v>3-MA</c:v>
                </c:pt>
                <c:pt idx="5">
                  <c:v>RSV+CFZ+3-MA</c:v>
                </c:pt>
              </c:strCache>
            </c:strRef>
          </c:cat>
          <c:val>
            <c:numRef>
              <c:f>Sheet1!$G$24:$G$29</c:f>
              <c:numCache>
                <c:formatCode>General</c:formatCode>
                <c:ptCount val="6"/>
                <c:pt idx="0">
                  <c:v>1</c:v>
                </c:pt>
                <c:pt idx="1">
                  <c:v>0.54720643599113272</c:v>
                </c:pt>
                <c:pt idx="2">
                  <c:v>0.51432232476198303</c:v>
                </c:pt>
                <c:pt idx="3">
                  <c:v>3.3933917552859687</c:v>
                </c:pt>
                <c:pt idx="4">
                  <c:v>0.80271134778973052</c:v>
                </c:pt>
                <c:pt idx="5">
                  <c:v>7.22279718020331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55427792"/>
        <c:axId val="255428352"/>
      </c:barChart>
      <c:catAx>
        <c:axId val="2554277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5428352"/>
        <c:crosses val="autoZero"/>
        <c:auto val="1"/>
        <c:lblAlgn val="ctr"/>
        <c:lblOffset val="100"/>
        <c:noMultiLvlLbl val="0"/>
      </c:catAx>
      <c:valAx>
        <c:axId val="25542835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542779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zh-CN" sz="1400" b="0" i="0" baseline="0" dirty="0"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62</a:t>
            </a:r>
            <a:endParaRPr lang="zh-CN" altLang="zh-CN" sz="1400" dirty="0"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52489482991055036"/>
          <c:y val="0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A$24:$A$29</c:f>
              <c:strCache>
                <c:ptCount val="6"/>
                <c:pt idx="0">
                  <c:v>con</c:v>
                </c:pt>
                <c:pt idx="1">
                  <c:v>RSV</c:v>
                </c:pt>
                <c:pt idx="2">
                  <c:v>CFZ</c:v>
                </c:pt>
                <c:pt idx="3">
                  <c:v>RSV+CFZ</c:v>
                </c:pt>
                <c:pt idx="4">
                  <c:v>3-MA</c:v>
                </c:pt>
                <c:pt idx="5">
                  <c:v>RSV+CFZ+3-MA</c:v>
                </c:pt>
              </c:strCache>
            </c:strRef>
          </c:cat>
          <c:val>
            <c:numRef>
              <c:f>Sheet1!$F$24:$F$29</c:f>
              <c:numCache>
                <c:formatCode>General</c:formatCode>
                <c:ptCount val="6"/>
                <c:pt idx="0">
                  <c:v>1</c:v>
                </c:pt>
                <c:pt idx="1">
                  <c:v>0.36702867199576777</c:v>
                </c:pt>
                <c:pt idx="2">
                  <c:v>0.33740210846368091</c:v>
                </c:pt>
                <c:pt idx="3">
                  <c:v>0.55069190789985634</c:v>
                </c:pt>
                <c:pt idx="4">
                  <c:v>0.50116683559237729</c:v>
                </c:pt>
                <c:pt idx="5">
                  <c:v>0.5284267418306886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100"/>
        <c:axId val="255430592"/>
        <c:axId val="255431152"/>
      </c:barChart>
      <c:catAx>
        <c:axId val="2554305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5431152"/>
        <c:crosses val="autoZero"/>
        <c:auto val="1"/>
        <c:lblAlgn val="ctr"/>
        <c:lblOffset val="100"/>
        <c:noMultiLvlLbl val="0"/>
      </c:catAx>
      <c:valAx>
        <c:axId val="2554311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5543059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136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84217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107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7654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539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0492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213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8522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057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3932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0986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9A864-4303-45CD-8BA5-C420116414AD}" type="datetimeFigureOut">
              <a:rPr lang="en-US" smtClean="0"/>
              <a:t>3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FE3327-ED22-4C6C-95DA-083B0A9959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376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56943" y="30275"/>
            <a:ext cx="787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5" name="Group 34"/>
          <p:cNvGrpSpPr/>
          <p:nvPr/>
        </p:nvGrpSpPr>
        <p:grpSpPr>
          <a:xfrm>
            <a:off x="1969352" y="249343"/>
            <a:ext cx="8445680" cy="6492161"/>
            <a:chOff x="1944968" y="261535"/>
            <a:chExt cx="8445680" cy="6492161"/>
          </a:xfrm>
        </p:grpSpPr>
        <p:grpSp>
          <p:nvGrpSpPr>
            <p:cNvPr id="29" name="Group 28"/>
            <p:cNvGrpSpPr/>
            <p:nvPr/>
          </p:nvGrpSpPr>
          <p:grpSpPr>
            <a:xfrm>
              <a:off x="1944968" y="261535"/>
              <a:ext cx="8445680" cy="3147534"/>
              <a:chOff x="1861701" y="455151"/>
              <a:chExt cx="8445680" cy="3147534"/>
            </a:xfrm>
          </p:grpSpPr>
          <p:graphicFrame>
            <p:nvGraphicFramePr>
              <p:cNvPr id="3" name="图表 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308177152"/>
                  </p:ext>
                </p:extLst>
              </p:nvPr>
            </p:nvGraphicFramePr>
            <p:xfrm>
              <a:off x="2257605" y="501863"/>
              <a:ext cx="2041807" cy="277221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4" name="图表 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190006458"/>
                  </p:ext>
                </p:extLst>
              </p:nvPr>
            </p:nvGraphicFramePr>
            <p:xfrm>
              <a:off x="5053711" y="639391"/>
              <a:ext cx="2041483" cy="268629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5" name="图表 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068652122"/>
                  </p:ext>
                </p:extLst>
              </p:nvPr>
            </p:nvGraphicFramePr>
            <p:xfrm>
              <a:off x="7903927" y="732150"/>
              <a:ext cx="1968843" cy="259353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6" name="TextBox 5"/>
              <p:cNvSpPr txBox="1"/>
              <p:nvPr/>
            </p:nvSpPr>
            <p:spPr>
              <a:xfrm>
                <a:off x="1861701" y="455151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 rot="5400000" flipV="1">
                <a:off x="1623482" y="1525998"/>
                <a:ext cx="112731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 rot="5400000" flipV="1">
                <a:off x="4423177" y="1525998"/>
                <a:ext cx="115695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4489757" y="500891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7442908" y="500890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 rot="5400000" flipV="1">
                <a:off x="7240132" y="1539267"/>
                <a:ext cx="113042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evels</a:t>
                </a:r>
              </a:p>
            </p:txBody>
          </p:sp>
          <p:cxnSp>
            <p:nvCxnSpPr>
              <p:cNvPr id="13" name="Straight Connector 12"/>
              <p:cNvCxnSpPr/>
              <p:nvPr/>
            </p:nvCxnSpPr>
            <p:spPr>
              <a:xfrm>
                <a:off x="2064031" y="3274075"/>
                <a:ext cx="824335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/>
              <p:cNvSpPr txBox="1"/>
              <p:nvPr/>
            </p:nvSpPr>
            <p:spPr>
              <a:xfrm>
                <a:off x="5939484" y="3325686"/>
                <a:ext cx="4924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P-1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34" name="Group 33"/>
            <p:cNvGrpSpPr/>
            <p:nvPr/>
          </p:nvGrpSpPr>
          <p:grpSpPr>
            <a:xfrm>
              <a:off x="2046133" y="3399299"/>
              <a:ext cx="8243350" cy="3354397"/>
              <a:chOff x="2046133" y="3399299"/>
              <a:chExt cx="8243350" cy="3354397"/>
            </a:xfrm>
          </p:grpSpPr>
          <p:grpSp>
            <p:nvGrpSpPr>
              <p:cNvPr id="20" name="Group 19"/>
              <p:cNvGrpSpPr/>
              <p:nvPr/>
            </p:nvGrpSpPr>
            <p:grpSpPr>
              <a:xfrm>
                <a:off x="2080002" y="3554472"/>
                <a:ext cx="2302677" cy="2767574"/>
                <a:chOff x="1804374" y="3750046"/>
                <a:chExt cx="2403241" cy="2492625"/>
              </a:xfrm>
            </p:grpSpPr>
            <p:graphicFrame>
              <p:nvGraphicFramePr>
                <p:cNvPr id="17" name="图表 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254634839"/>
                    </p:ext>
                  </p:extLst>
                </p:nvPr>
              </p:nvGraphicFramePr>
              <p:xfrm>
                <a:off x="1955983" y="3750046"/>
                <a:ext cx="2251632" cy="2492625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sp>
              <p:nvSpPr>
                <p:cNvPr id="19" name="TextBox 18"/>
                <p:cNvSpPr txBox="1"/>
                <p:nvPr/>
              </p:nvSpPr>
              <p:spPr>
                <a:xfrm rot="5400000" flipV="1">
                  <a:off x="1363825" y="4467594"/>
                  <a:ext cx="1127319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lative </a:t>
                  </a:r>
                  <a:r>
                    <a:rPr lang="en-US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evels</a:t>
                  </a:r>
                </a:p>
              </p:txBody>
            </p:sp>
          </p:grpSp>
          <p:grpSp>
            <p:nvGrpSpPr>
              <p:cNvPr id="26" name="Group 25"/>
              <p:cNvGrpSpPr/>
              <p:nvPr/>
            </p:nvGrpSpPr>
            <p:grpSpPr>
              <a:xfrm>
                <a:off x="7719013" y="3477432"/>
                <a:ext cx="2463140" cy="3006171"/>
                <a:chOff x="7572286" y="3621750"/>
                <a:chExt cx="2479239" cy="2696548"/>
              </a:xfrm>
            </p:grpSpPr>
            <p:sp>
              <p:nvSpPr>
                <p:cNvPr id="22" name="TextBox 21"/>
                <p:cNvSpPr txBox="1"/>
                <p:nvPr/>
              </p:nvSpPr>
              <p:spPr>
                <a:xfrm rot="5400000" flipV="1">
                  <a:off x="7125154" y="4386764"/>
                  <a:ext cx="1127319" cy="23305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lative </a:t>
                  </a:r>
                  <a:r>
                    <a:rPr lang="en-US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evels</a:t>
                  </a:r>
                </a:p>
              </p:txBody>
            </p:sp>
            <p:graphicFrame>
              <p:nvGraphicFramePr>
                <p:cNvPr id="23" name="图表 6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691528778"/>
                    </p:ext>
                  </p:extLst>
                </p:nvPr>
              </p:nvGraphicFramePr>
              <p:xfrm>
                <a:off x="7805341" y="3621750"/>
                <a:ext cx="2246184" cy="269654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</p:grpSp>
          <p:grpSp>
            <p:nvGrpSpPr>
              <p:cNvPr id="25" name="Group 24"/>
              <p:cNvGrpSpPr/>
              <p:nvPr/>
            </p:nvGrpSpPr>
            <p:grpSpPr>
              <a:xfrm>
                <a:off x="4847662" y="3654772"/>
                <a:ext cx="2369793" cy="2796684"/>
                <a:chOff x="4653484" y="3563949"/>
                <a:chExt cx="2579924" cy="2871701"/>
              </a:xfrm>
            </p:grpSpPr>
            <p:graphicFrame>
              <p:nvGraphicFramePr>
                <p:cNvPr id="21" name="图表 5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135140557"/>
                    </p:ext>
                  </p:extLst>
                </p:nvPr>
              </p:nvGraphicFramePr>
              <p:xfrm>
                <a:off x="4878545" y="3563949"/>
                <a:ext cx="2354863" cy="2871701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  <p:sp>
              <p:nvSpPr>
                <p:cNvPr id="24" name="TextBox 23"/>
                <p:cNvSpPr txBox="1"/>
                <p:nvPr/>
              </p:nvSpPr>
              <p:spPr>
                <a:xfrm rot="5400000" flipV="1">
                  <a:off x="4149432" y="4445223"/>
                  <a:ext cx="1271201" cy="26309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lative </a:t>
                  </a:r>
                  <a:r>
                    <a:rPr lang="en-US" sz="10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evels</a:t>
                  </a:r>
                </a:p>
              </p:txBody>
            </p:sp>
          </p:grpSp>
          <p:sp>
            <p:nvSpPr>
              <p:cNvPr id="27" name="TextBox 26"/>
              <p:cNvSpPr txBox="1"/>
              <p:nvPr/>
            </p:nvSpPr>
            <p:spPr>
              <a:xfrm>
                <a:off x="4687647" y="3426732"/>
                <a:ext cx="2792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7584200" y="3477432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2062685" y="3399299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1" name="Straight Connector 30"/>
              <p:cNvCxnSpPr/>
              <p:nvPr/>
            </p:nvCxnSpPr>
            <p:spPr>
              <a:xfrm>
                <a:off x="2046133" y="6476697"/>
                <a:ext cx="824335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Box 31"/>
              <p:cNvSpPr txBox="1"/>
              <p:nvPr/>
            </p:nvSpPr>
            <p:spPr>
              <a:xfrm>
                <a:off x="5976279" y="6476697"/>
                <a:ext cx="65755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M.1S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1961621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1</TotalTime>
  <Words>32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an,Ping</dc:creator>
  <cp:lastModifiedBy>Fan,Ping</cp:lastModifiedBy>
  <cp:revision>29</cp:revision>
  <dcterms:created xsi:type="dcterms:W3CDTF">2018-03-12T14:59:56Z</dcterms:created>
  <dcterms:modified xsi:type="dcterms:W3CDTF">2018-03-13T17:09:16Z</dcterms:modified>
</cp:coreProperties>
</file>